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2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02" autoAdjust="0"/>
    <p:restoredTop sz="93597" autoAdjust="0"/>
  </p:normalViewPr>
  <p:slideViewPr>
    <p:cSldViewPr>
      <p:cViewPr>
        <p:scale>
          <a:sx n="125" d="100"/>
          <a:sy n="125" d="100"/>
        </p:scale>
        <p:origin x="-1524" y="318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Molecular%20Oncology\Livio%20Trusolino\Tankyrase%20&amp;%20TNIK\Group\PROGETTI\Tankyrase\TNKS%20paper\PAPER\BMC%20Biology\REVISION\ADDITIONAL%20FILES\Additional%20File%208_Fig.S3_Raw%20data_Diamond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Molecular%20Oncology\Livio%20Trusolino\Tankyrase%20&amp;%20TNIK\Group\PROGETTI\Tankyrase\TNKS%20paper\PAPER\BMC%20Biology\REVISION\ADDITIONAL%20FILES\Additional%20File%208_Fig.S3_Raw%20data_Diamond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ssandra-3\WorkSpaces\%23%23%20Molecular%20Oncology\Livio%20Trusolino\Tankyrase%20&amp;%20TNIK\Group\PROGETTI\Tankyrase\TNKS%20paper\PAPER\BMC%20Biology\REVISION\ADDITIONAL%20FILES\Additional%20File%208_Fig.S3_Raw%20data_Diamond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Fig.S3A (paper)'!$N$24:$S$24</c:f>
              <c:numCache>
                <c:formatCode>General</c:formatCode>
                <c:ptCount val="6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</c:numCache>
            </c:numRef>
          </c:xVal>
          <c:yVal>
            <c:numRef>
              <c:f>'Fig.S3A (paper)'!$N$25:$S$25</c:f>
              <c:numCache>
                <c:formatCode>General</c:formatCode>
                <c:ptCount val="6"/>
                <c:pt idx="1">
                  <c:v>-2.1085263333333302</c:v>
                </c:pt>
                <c:pt idx="4">
                  <c:v>-2.3318970000000014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Fig.S3A (paper)'!$N$24:$S$24</c:f>
              <c:numCache>
                <c:formatCode>General</c:formatCode>
                <c:ptCount val="6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</c:numCache>
            </c:numRef>
          </c:xVal>
          <c:yVal>
            <c:numRef>
              <c:f>'Fig.S3A (paper)'!$N$26:$S$26</c:f>
              <c:numCache>
                <c:formatCode>General</c:formatCode>
                <c:ptCount val="6"/>
                <c:pt idx="1">
                  <c:v>-1.979354500000003</c:v>
                </c:pt>
                <c:pt idx="4">
                  <c:v>-2.0716528333333315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Fig.S3A (paper)'!$N$24:$S$24</c:f>
              <c:numCache>
                <c:formatCode>General</c:formatCode>
                <c:ptCount val="6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</c:numCache>
            </c:numRef>
          </c:xVal>
          <c:yVal>
            <c:numRef>
              <c:f>'Fig.S3A (paper)'!$N$27:$S$27</c:f>
              <c:numCache>
                <c:formatCode>General</c:formatCode>
                <c:ptCount val="6"/>
                <c:pt idx="0">
                  <c:v>-2.0439404166666666</c:v>
                </c:pt>
                <c:pt idx="1">
                  <c:v>-2.0439404166666666</c:v>
                </c:pt>
                <c:pt idx="2">
                  <c:v>-2.0439404166666666</c:v>
                </c:pt>
                <c:pt idx="3">
                  <c:v>-2.2017749166666665</c:v>
                </c:pt>
                <c:pt idx="4">
                  <c:v>-2.2017749166666665</c:v>
                </c:pt>
                <c:pt idx="5">
                  <c:v>-2.201774916666666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467008"/>
        <c:axId val="79467584"/>
      </c:scatterChart>
      <c:valAx>
        <c:axId val="79467008"/>
        <c:scaling>
          <c:orientation val="minMax"/>
          <c:max val="3"/>
          <c:min val="0"/>
        </c:scaling>
        <c:delete val="0"/>
        <c:axPos val="b"/>
        <c:numFmt formatCode="General" sourceLinked="1"/>
        <c:majorTickMark val="in"/>
        <c:minorTickMark val="none"/>
        <c:tickLblPos val="none"/>
        <c:txPr>
          <a:bodyPr rot="0" vert="horz"/>
          <a:lstStyle/>
          <a:p>
            <a:pPr>
              <a:defRPr sz="11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it-IT"/>
          </a:p>
        </c:txPr>
        <c:crossAx val="79467584"/>
        <c:crosses val="autoZero"/>
        <c:crossBetween val="midCat"/>
        <c:majorUnit val="1"/>
      </c:valAx>
      <c:valAx>
        <c:axId val="79467584"/>
        <c:scaling>
          <c:orientation val="minMax"/>
          <c:max val="0"/>
          <c:min val="-2.5"/>
        </c:scaling>
        <c:delete val="0"/>
        <c:axPos val="l"/>
        <c:numFmt formatCode="General" sourceLinked="1"/>
        <c:majorTickMark val="out"/>
        <c:minorTickMark val="none"/>
        <c:tickLblPos val="nextTo"/>
        <c:crossAx val="79467008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/>
      </a:pPr>
      <a:endParaRPr lang="it-IT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Fig.S3C (paper)'!$F$14</c:f>
              <c:strCache>
                <c:ptCount val="1"/>
                <c:pt idx="0">
                  <c:v>Average 1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Fig.S3C (paper)'!$G$13:$O$13</c:f>
              <c:numCache>
                <c:formatCode>General</c:formatCode>
                <c:ptCount val="9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</c:numCache>
            </c:numRef>
          </c:xVal>
          <c:yVal>
            <c:numRef>
              <c:f>'Fig.S3C (paper)'!$G$14:$O$14</c:f>
              <c:numCache>
                <c:formatCode>General</c:formatCode>
                <c:ptCount val="9"/>
                <c:pt idx="1">
                  <c:v>1.6961209472264431</c:v>
                </c:pt>
                <c:pt idx="4">
                  <c:v>0.79029724607741025</c:v>
                </c:pt>
                <c:pt idx="7">
                  <c:v>0.513581806696146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.S3C (paper)'!$F$15</c:f>
              <c:strCache>
                <c:ptCount val="1"/>
                <c:pt idx="0">
                  <c:v>Average 2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Fig.S3C (paper)'!$G$13:$O$13</c:f>
              <c:numCache>
                <c:formatCode>General</c:formatCode>
                <c:ptCount val="9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</c:numCache>
            </c:numRef>
          </c:xVal>
          <c:yVal>
            <c:numRef>
              <c:f>'Fig.S3C (paper)'!$G$15:$O$15</c:f>
              <c:numCache>
                <c:formatCode>General</c:formatCode>
                <c:ptCount val="9"/>
                <c:pt idx="1">
                  <c:v>1.8438719378723567</c:v>
                </c:pt>
                <c:pt idx="4">
                  <c:v>0.70116298989283754</c:v>
                </c:pt>
                <c:pt idx="7">
                  <c:v>0.45496507223480598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.S3C (paper)'!$F$16</c:f>
              <c:strCache>
                <c:ptCount val="1"/>
                <c:pt idx="0">
                  <c:v>Average 1+2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marker>
          <c:xVal>
            <c:numRef>
              <c:f>'Fig.S3C (paper)'!$G$13:$O$13</c:f>
              <c:numCache>
                <c:formatCode>General</c:formatCode>
                <c:ptCount val="9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  <c:pt idx="6">
                  <c:v>2.9</c:v>
                </c:pt>
                <c:pt idx="7">
                  <c:v>3</c:v>
                </c:pt>
                <c:pt idx="8">
                  <c:v>3.1</c:v>
                </c:pt>
              </c:numCache>
            </c:numRef>
          </c:xVal>
          <c:yVal>
            <c:numRef>
              <c:f>'Fig.S3C (paper)'!$G$16:$O$16</c:f>
              <c:numCache>
                <c:formatCode>0.00</c:formatCode>
                <c:ptCount val="9"/>
                <c:pt idx="0">
                  <c:v>1.7699964425493999</c:v>
                </c:pt>
                <c:pt idx="1">
                  <c:v>1.7699964425493999</c:v>
                </c:pt>
                <c:pt idx="2">
                  <c:v>1.7699964425493999</c:v>
                </c:pt>
                <c:pt idx="3">
                  <c:v>0.7457301179851239</c:v>
                </c:pt>
                <c:pt idx="4">
                  <c:v>0.7457301179851239</c:v>
                </c:pt>
                <c:pt idx="5">
                  <c:v>0.7457301179851239</c:v>
                </c:pt>
                <c:pt idx="6">
                  <c:v>0.48427343946547624</c:v>
                </c:pt>
                <c:pt idx="7">
                  <c:v>0.48427343946547624</c:v>
                </c:pt>
                <c:pt idx="8">
                  <c:v>0.4842734394654762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469312"/>
        <c:axId val="79469888"/>
      </c:scatterChart>
      <c:valAx>
        <c:axId val="79469312"/>
        <c:scaling>
          <c:orientation val="minMax"/>
          <c:max val="3.5"/>
          <c:min val="0.5"/>
        </c:scaling>
        <c:delete val="0"/>
        <c:axPos val="b"/>
        <c:numFmt formatCode="General" sourceLinked="1"/>
        <c:majorTickMark val="out"/>
        <c:minorTickMark val="none"/>
        <c:tickLblPos val="none"/>
        <c:crossAx val="79469888"/>
        <c:crosses val="autoZero"/>
        <c:crossBetween val="midCat"/>
        <c:majorUnit val="1"/>
      </c:valAx>
      <c:valAx>
        <c:axId val="794698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79469312"/>
        <c:crosses val="autoZero"/>
        <c:crossBetween val="midCat"/>
        <c:maj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Fig.S3D (paper)'!$L$7</c:f>
              <c:strCache>
                <c:ptCount val="1"/>
                <c:pt idx="0">
                  <c:v>Average 1st exp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Fig.S3D (paper)'!$P$6:$U$6</c:f>
              <c:numCache>
                <c:formatCode>General</c:formatCode>
                <c:ptCount val="6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</c:numCache>
            </c:numRef>
          </c:xVal>
          <c:yVal>
            <c:numRef>
              <c:f>'Fig.S3D (paper)'!$P$7:$U$7</c:f>
              <c:numCache>
                <c:formatCode>General</c:formatCode>
                <c:ptCount val="6"/>
                <c:pt idx="1">
                  <c:v>0.78625580826607966</c:v>
                </c:pt>
                <c:pt idx="4">
                  <c:v>1.320616287600880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.S3D (paper)'!$L$8</c:f>
              <c:strCache>
                <c:ptCount val="1"/>
                <c:pt idx="0">
                  <c:v>Average 2nd exp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'Fig.S3D (paper)'!$P$6:$U$6</c:f>
              <c:numCache>
                <c:formatCode>General</c:formatCode>
                <c:ptCount val="6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</c:numCache>
            </c:numRef>
          </c:xVal>
          <c:yVal>
            <c:numRef>
              <c:f>'Fig.S3D (paper)'!$P$8:$U$8</c:f>
              <c:numCache>
                <c:formatCode>General</c:formatCode>
                <c:ptCount val="6"/>
                <c:pt idx="1">
                  <c:v>0.6324269889224573</c:v>
                </c:pt>
                <c:pt idx="4">
                  <c:v>1.3675730110775428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.S3D (paper)'!$L$9</c:f>
              <c:strCache>
                <c:ptCount val="1"/>
                <c:pt idx="0">
                  <c:v>Average 1+2 exp</c:v>
                </c:pt>
              </c:strCache>
            </c:strRef>
          </c:tx>
          <c:spPr>
            <a:ln w="28575">
              <a:noFill/>
            </a:ln>
          </c:spPr>
          <c:marker>
            <c:symbol val="dash"/>
            <c:size val="7"/>
            <c:spPr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marker>
          <c:xVal>
            <c:numRef>
              <c:f>'Fig.S3D (paper)'!$P$6:$U$6</c:f>
              <c:numCache>
                <c:formatCode>General</c:formatCode>
                <c:ptCount val="6"/>
                <c:pt idx="0">
                  <c:v>0.9</c:v>
                </c:pt>
                <c:pt idx="1">
                  <c:v>1</c:v>
                </c:pt>
                <c:pt idx="2">
                  <c:v>1.1000000000000001</c:v>
                </c:pt>
                <c:pt idx="3">
                  <c:v>1.9</c:v>
                </c:pt>
                <c:pt idx="4">
                  <c:v>2</c:v>
                </c:pt>
                <c:pt idx="5">
                  <c:v>2.1</c:v>
                </c:pt>
              </c:numCache>
            </c:numRef>
          </c:xVal>
          <c:yVal>
            <c:numRef>
              <c:f>'Fig.S3D (paper)'!$P$9:$U$9</c:f>
              <c:numCache>
                <c:formatCode>General</c:formatCode>
                <c:ptCount val="6"/>
                <c:pt idx="0">
                  <c:v>0.70934139859426848</c:v>
                </c:pt>
                <c:pt idx="1">
                  <c:v>0.70934139859426848</c:v>
                </c:pt>
                <c:pt idx="2">
                  <c:v>0.70934139859426848</c:v>
                </c:pt>
                <c:pt idx="3">
                  <c:v>1.3440946493392114</c:v>
                </c:pt>
                <c:pt idx="4">
                  <c:v>1.3440946493392114</c:v>
                </c:pt>
                <c:pt idx="5">
                  <c:v>1.344094649339211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544896"/>
        <c:axId val="80545472"/>
      </c:scatterChart>
      <c:valAx>
        <c:axId val="80544896"/>
        <c:scaling>
          <c:orientation val="minMax"/>
          <c:max val="3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crossAx val="80545472"/>
        <c:crosses val="autoZero"/>
        <c:crossBetween val="midCat"/>
        <c:majorUnit val="1"/>
      </c:valAx>
      <c:valAx>
        <c:axId val="80545472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80544896"/>
        <c:crosses val="autoZero"/>
        <c:crossBetween val="midCat"/>
        <c:majorUnit val="0.5"/>
      </c:valAx>
      <c:spPr>
        <a:ln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9" y="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227257D7-D7BE-4475-912D-A861A539B70E}" type="datetimeFigureOut">
              <a:rPr lang="it-IT" smtClean="0"/>
              <a:pPr/>
              <a:t>14/12/201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164"/>
            <a:ext cx="2946400" cy="496887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9" y="9428164"/>
            <a:ext cx="2946400" cy="496887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2B067331-E300-493D-B25C-E95C2384BC2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9488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5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8F4DDC09-3A55-4B16-AD34-7AD3F499AB41}" type="datetimeFigureOut">
              <a:rPr lang="it-IT" smtClean="0"/>
              <a:pPr/>
              <a:t>14/12/2015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5"/>
            <a:ext cx="5438140" cy="4466987"/>
          </a:xfrm>
          <a:prstGeom prst="rect">
            <a:avLst/>
          </a:prstGeom>
        </p:spPr>
        <p:txBody>
          <a:bodyPr vert="horz" lIns="91432" tIns="45716" rIns="91432" bIns="45716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5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CF1D5D10-F67F-430D-926A-A83F6D16763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0871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1375" y="744538"/>
            <a:ext cx="25749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it-IT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1D5D10-F67F-430D-926A-A83F6D16763D}" type="slidenum">
              <a:rPr lang="it-IT" smtClean="0"/>
              <a:pPr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689288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9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7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7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2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3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2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tiff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chart" Target="../charts/chart3.xml"/><Relationship Id="rId5" Type="http://schemas.openxmlformats.org/officeDocument/2006/relationships/image" Target="../media/image3.tiff"/><Relationship Id="rId10" Type="http://schemas.openxmlformats.org/officeDocument/2006/relationships/chart" Target="../charts/chart2.xml"/><Relationship Id="rId4" Type="http://schemas.openxmlformats.org/officeDocument/2006/relationships/image" Target="../media/image2.tiff"/><Relationship Id="rId9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6"/>
          <p:cNvSpPr txBox="1">
            <a:spLocks noChangeArrowheads="1"/>
          </p:cNvSpPr>
          <p:nvPr/>
        </p:nvSpPr>
        <p:spPr bwMode="auto">
          <a:xfrm>
            <a:off x="2479197" y="178373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tin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26"/>
          <p:cNvSpPr txBox="1">
            <a:spLocks noChangeArrowheads="1"/>
          </p:cNvSpPr>
          <p:nvPr/>
        </p:nvSpPr>
        <p:spPr bwMode="auto">
          <a:xfrm>
            <a:off x="2479197" y="125033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xin1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 Box 26"/>
          <p:cNvSpPr txBox="1">
            <a:spLocks noChangeArrowheads="1"/>
          </p:cNvSpPr>
          <p:nvPr/>
        </p:nvSpPr>
        <p:spPr bwMode="auto">
          <a:xfrm rot="19032980">
            <a:off x="2327379" y="2222226"/>
            <a:ext cx="145838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0" name="Text Box 26"/>
          <p:cNvSpPr txBox="1">
            <a:spLocks noChangeArrowheads="1"/>
          </p:cNvSpPr>
          <p:nvPr/>
        </p:nvSpPr>
        <p:spPr bwMode="auto">
          <a:xfrm>
            <a:off x="2545193" y="756319"/>
            <a:ext cx="56673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>
                <a:latin typeface="Arial" panose="020B0604020202020204" pitchFamily="34" charset="0"/>
                <a:cs typeface="Arial" panose="020B0604020202020204" pitchFamily="34" charset="0"/>
              </a:rPr>
              <a:t>TNKS</a:t>
            </a:r>
          </a:p>
        </p:txBody>
      </p:sp>
      <p:sp>
        <p:nvSpPr>
          <p:cNvPr id="13" name="Text Box 49"/>
          <p:cNvSpPr txBox="1">
            <a:spLocks noChangeArrowheads="1"/>
          </p:cNvSpPr>
          <p:nvPr/>
        </p:nvSpPr>
        <p:spPr bwMode="auto">
          <a:xfrm>
            <a:off x="103866" y="247651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 Box 49"/>
          <p:cNvSpPr txBox="1">
            <a:spLocks noChangeArrowheads="1"/>
          </p:cNvSpPr>
          <p:nvPr/>
        </p:nvSpPr>
        <p:spPr bwMode="auto">
          <a:xfrm>
            <a:off x="2458651" y="247651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 Box 49"/>
          <p:cNvSpPr txBox="1">
            <a:spLocks noChangeArrowheads="1"/>
          </p:cNvSpPr>
          <p:nvPr/>
        </p:nvSpPr>
        <p:spPr bwMode="auto">
          <a:xfrm>
            <a:off x="4475812" y="238471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26"/>
          <p:cNvSpPr txBox="1">
            <a:spLocks noChangeArrowheads="1"/>
          </p:cNvSpPr>
          <p:nvPr/>
        </p:nvSpPr>
        <p:spPr bwMode="auto">
          <a:xfrm>
            <a:off x="4908153" y="2132951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26"/>
          <p:cNvSpPr txBox="1">
            <a:spLocks noChangeArrowheads="1"/>
          </p:cNvSpPr>
          <p:nvPr/>
        </p:nvSpPr>
        <p:spPr bwMode="auto">
          <a:xfrm>
            <a:off x="5293593" y="2132340"/>
            <a:ext cx="97788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1/2</a:t>
            </a:r>
          </a:p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26"/>
          <p:cNvSpPr txBox="1">
            <a:spLocks noChangeArrowheads="1"/>
          </p:cNvSpPr>
          <p:nvPr/>
        </p:nvSpPr>
        <p:spPr bwMode="auto">
          <a:xfrm>
            <a:off x="5949063" y="213234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XAV93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 Box 51"/>
          <p:cNvSpPr txBox="1">
            <a:spLocks noChangeArrowheads="1"/>
          </p:cNvSpPr>
          <p:nvPr/>
        </p:nvSpPr>
        <p:spPr bwMode="auto">
          <a:xfrm rot="16200000">
            <a:off x="3658403" y="1207224"/>
            <a:ext cx="17107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nvasion 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fold change against average)</a:t>
            </a:r>
          </a:p>
        </p:txBody>
      </p:sp>
      <p:pic>
        <p:nvPicPr>
          <p:cNvPr id="16386" name="Picture 2" descr="\\Cassandra-3\Tankyrase &amp; TNIK\Group\grafici paper\wb\genetic TNKS silencing\300 dpi\H460 stable TNKS silencing_TNKS.tif"/>
          <p:cNvPicPr>
            <a:picLocks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9678" r="-5209"/>
          <a:stretch/>
        </p:blipFill>
        <p:spPr bwMode="auto">
          <a:xfrm>
            <a:off x="2993365" y="524650"/>
            <a:ext cx="1058243" cy="5333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87" name="Picture 3" descr="\\Cassandra-3\Tankyrase &amp; TNIK\Group\grafici paper\wb\genetic TNKS silencing\300 dpi\H460 stable TNKS silencing_AXIN1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0858" r="-462" b="-1"/>
          <a:stretch/>
        </p:blipFill>
        <p:spPr bwMode="auto">
          <a:xfrm>
            <a:off x="3003579" y="1057964"/>
            <a:ext cx="1010485" cy="5390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88" name="Picture 4" descr="\\Cassandra-3\Tankyrase &amp; TNIK\Group\grafici paper\wb\genetic TNKS silencing\300 dpi\H460 stable TNKS silencing _ACTIN.tif"/>
          <p:cNvPicPr>
            <a:picLocks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-10425" r="-1592" b="-1"/>
          <a:stretch/>
        </p:blipFill>
        <p:spPr bwMode="auto">
          <a:xfrm>
            <a:off x="3003579" y="1597024"/>
            <a:ext cx="1010486" cy="5369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9" name="Text Box 50"/>
          <p:cNvSpPr txBox="1">
            <a:spLocks noChangeArrowheads="1"/>
          </p:cNvSpPr>
          <p:nvPr/>
        </p:nvSpPr>
        <p:spPr bwMode="auto">
          <a:xfrm rot="16200000">
            <a:off x="-334338" y="1276337"/>
            <a:ext cx="159531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expression, Log2R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normalized to mock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 Box 26"/>
          <p:cNvSpPr txBox="1">
            <a:spLocks noChangeArrowheads="1"/>
          </p:cNvSpPr>
          <p:nvPr/>
        </p:nvSpPr>
        <p:spPr bwMode="auto">
          <a:xfrm>
            <a:off x="1096587" y="497505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 Box 26"/>
          <p:cNvSpPr txBox="1">
            <a:spLocks noChangeArrowheads="1"/>
          </p:cNvSpPr>
          <p:nvPr/>
        </p:nvSpPr>
        <p:spPr bwMode="auto">
          <a:xfrm>
            <a:off x="1673805" y="497505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2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469721" y="9588515"/>
            <a:ext cx="23791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upo et al.,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: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 Box 26"/>
          <p:cNvSpPr txBox="1">
            <a:spLocks noChangeArrowheads="1"/>
          </p:cNvSpPr>
          <p:nvPr/>
        </p:nvSpPr>
        <p:spPr bwMode="auto">
          <a:xfrm rot="8075714" flipV="1">
            <a:off x="3076914" y="2213574"/>
            <a:ext cx="71883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1/2</a:t>
            </a:r>
          </a:p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55297" y="5088015"/>
            <a:ext cx="6089038" cy="40164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6: Figure S2. RNA 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interference-mediated downregulation of TNKS phenocopies pharmacologic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hibition in impairing cell invasion and migration</a:t>
            </a:r>
          </a:p>
          <a:p>
            <a:pPr algn="just"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, Expression of TNKS and TNKS2 mRNA in A549 cell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ransduc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on-targeting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mock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-infect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th a pair 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hRNA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argeting TNKS an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NKS2 to achieve double silencing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sults are presented a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average (lines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± range of two independent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s (diamonds)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ach performed in technical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riplicate.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B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NKS1/2 an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xin1 in total protein extracts from A549 cells transduced with the control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mock) or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NKS1/2-directed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or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eated with XAV939 (10 </a:t>
            </a:r>
            <a:r>
              <a:rPr lang="en-US" sz="1000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for 24 h. Both TNKS1/2 silencing and treatment with XAV939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sult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axin1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tabilization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XAV939 also induces TNKS stabilization, in accordance with the notion that TNKS auto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ARsylatio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leads to protei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uto-degradation. Molecular weights are indicated. 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ageJ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quantification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GF-induc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vasio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f A549 cells i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indicate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nditions (HGF, 50 ng/ml; XAV939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10 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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)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ta are th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verage (lines) ± range of two independent experiments (diamonds), each performed in technical duplicate. 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llustrative image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f a scratch assay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erformed with A549 cells in the specifi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perimental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nditions (HG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50 ng/ml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lots</a:t>
            </a:r>
            <a:r>
              <a:rPr lang="en-US" sz="1000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right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ow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mageJ quantification of wound repair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hibition</a:t>
            </a:r>
            <a:r>
              <a:rPr lang="en-US" sz="1000" dirty="0" smtClean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 from scratch. Dat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average (lines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± range of two independent experiment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iamonds), each perform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echnical triplicate. Raw data for panels A, C and D are shown in Additional File 7.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Group 17"/>
          <p:cNvGrpSpPr/>
          <p:nvPr/>
        </p:nvGrpSpPr>
        <p:grpSpPr>
          <a:xfrm>
            <a:off x="3997078" y="1269119"/>
            <a:ext cx="377027" cy="230832"/>
            <a:chOff x="-785040" y="1460009"/>
            <a:chExt cx="377027" cy="230832"/>
          </a:xfrm>
        </p:grpSpPr>
        <p:sp>
          <p:nvSpPr>
            <p:cNvPr id="40" name="Text Box 97"/>
            <p:cNvSpPr txBox="1">
              <a:spLocks noChangeArrowheads="1"/>
            </p:cNvSpPr>
            <p:nvPr/>
          </p:nvSpPr>
          <p:spPr bwMode="auto">
            <a:xfrm>
              <a:off x="-785040" y="1460009"/>
              <a:ext cx="377027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Straight Connector 14"/>
            <p:cNvCxnSpPr/>
            <p:nvPr/>
          </p:nvCxnSpPr>
          <p:spPr>
            <a:xfrm flipH="1">
              <a:off x="-756465" y="1585406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" name="Group 242"/>
          <p:cNvGrpSpPr/>
          <p:nvPr/>
        </p:nvGrpSpPr>
        <p:grpSpPr>
          <a:xfrm>
            <a:off x="4042083" y="1781603"/>
            <a:ext cx="316392" cy="230832"/>
            <a:chOff x="-756465" y="1460009"/>
            <a:chExt cx="316392" cy="230832"/>
          </a:xfrm>
        </p:grpSpPr>
        <p:sp>
          <p:nvSpPr>
            <p:cNvPr id="43" name="Text Box 97"/>
            <p:cNvSpPr txBox="1">
              <a:spLocks noChangeArrowheads="1"/>
            </p:cNvSpPr>
            <p:nvPr/>
          </p:nvSpPr>
          <p:spPr bwMode="auto">
            <a:xfrm>
              <a:off x="-752980" y="1460009"/>
              <a:ext cx="312907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Straight Connector 252"/>
            <p:cNvCxnSpPr/>
            <p:nvPr/>
          </p:nvCxnSpPr>
          <p:spPr>
            <a:xfrm flipH="1">
              <a:off x="-756465" y="1585406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0" name="Group 17"/>
          <p:cNvGrpSpPr/>
          <p:nvPr/>
        </p:nvGrpSpPr>
        <p:grpSpPr>
          <a:xfrm>
            <a:off x="3996863" y="587515"/>
            <a:ext cx="377027" cy="230832"/>
            <a:chOff x="-785040" y="1460009"/>
            <a:chExt cx="377027" cy="230832"/>
          </a:xfrm>
        </p:grpSpPr>
        <p:sp>
          <p:nvSpPr>
            <p:cNvPr id="51" name="Text Box 97"/>
            <p:cNvSpPr txBox="1">
              <a:spLocks noChangeArrowheads="1"/>
            </p:cNvSpPr>
            <p:nvPr/>
          </p:nvSpPr>
          <p:spPr bwMode="auto">
            <a:xfrm>
              <a:off x="-785040" y="1460009"/>
              <a:ext cx="377027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Straight Connector 14"/>
            <p:cNvCxnSpPr/>
            <p:nvPr/>
          </p:nvCxnSpPr>
          <p:spPr>
            <a:xfrm flipH="1">
              <a:off x="-756465" y="1576123"/>
              <a:ext cx="4572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38" name="Picture 5" descr="K:\## Molecular Oncology\Livio Trusolino\Tankyrase &amp; TNIK\Group\Tankyrase\1-Quaderni\Tankyrase - da settembre 2012\2015\Revisione_wound healing shRNA TNKS\wound shTNKS_1st\crop\300 dpi\T0_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441555" y="3539552"/>
            <a:ext cx="1539937" cy="32997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7" descr="K:\## Molecular Oncology\Livio Trusolino\Tankyrase &amp; TNIK\Group\Tankyrase\1-Quaderni\Tankyrase - da settembre 2012\2015\Revisione_wound healing shRNA TNKS\wound shTNKS_1st\crop\300 dpi\scr-HGF_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890873" y="3539552"/>
            <a:ext cx="1539937" cy="32997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9" name="Picture 8" descr="K:\## Molecular Oncology\Livio Trusolino\Tankyrase &amp; TNIK\Group\Tankyrase\1-Quaderni\Tankyrase - da settembre 2012\2015\Revisione_wound healing shRNA TNKS\wound shTNKS_1st\crop\300 dpi\shTNK-HGF_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348978" y="3539552"/>
            <a:ext cx="1539937" cy="32997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4" name="Text Box 49"/>
          <p:cNvSpPr txBox="1">
            <a:spLocks noChangeArrowheads="1"/>
          </p:cNvSpPr>
          <p:nvPr/>
        </p:nvSpPr>
        <p:spPr bwMode="auto">
          <a:xfrm>
            <a:off x="1136603" y="4506590"/>
            <a:ext cx="158825" cy="158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5" name="Text Box 49"/>
          <p:cNvSpPr txBox="1">
            <a:spLocks noChangeArrowheads="1"/>
          </p:cNvSpPr>
          <p:nvPr/>
        </p:nvSpPr>
        <p:spPr bwMode="auto">
          <a:xfrm>
            <a:off x="789744" y="4496244"/>
            <a:ext cx="327690" cy="158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GF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 Box 49"/>
          <p:cNvSpPr txBox="1">
            <a:spLocks noChangeArrowheads="1"/>
          </p:cNvSpPr>
          <p:nvPr/>
        </p:nvSpPr>
        <p:spPr bwMode="auto">
          <a:xfrm>
            <a:off x="1551733" y="4506590"/>
            <a:ext cx="179362" cy="158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8" name="Text Box 49"/>
          <p:cNvSpPr txBox="1">
            <a:spLocks noChangeArrowheads="1"/>
          </p:cNvSpPr>
          <p:nvPr/>
        </p:nvSpPr>
        <p:spPr bwMode="auto">
          <a:xfrm>
            <a:off x="2017830" y="4506590"/>
            <a:ext cx="179362" cy="158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0" name="Text Box 49"/>
          <p:cNvSpPr txBox="1">
            <a:spLocks noChangeArrowheads="1"/>
          </p:cNvSpPr>
          <p:nvPr/>
        </p:nvSpPr>
        <p:spPr bwMode="auto">
          <a:xfrm>
            <a:off x="1566657" y="4682533"/>
            <a:ext cx="158825" cy="158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1" name="Text Box 49"/>
          <p:cNvSpPr txBox="1">
            <a:spLocks noChangeArrowheads="1"/>
          </p:cNvSpPr>
          <p:nvPr/>
        </p:nvSpPr>
        <p:spPr bwMode="auto">
          <a:xfrm>
            <a:off x="2027183" y="4682533"/>
            <a:ext cx="179362" cy="158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2" name="Text Box 49"/>
          <p:cNvSpPr txBox="1">
            <a:spLocks noChangeArrowheads="1"/>
          </p:cNvSpPr>
          <p:nvPr/>
        </p:nvSpPr>
        <p:spPr bwMode="auto">
          <a:xfrm>
            <a:off x="1129475" y="4682533"/>
            <a:ext cx="158825" cy="158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4" name="Right Bracket 63"/>
          <p:cNvSpPr/>
          <p:nvPr/>
        </p:nvSpPr>
        <p:spPr>
          <a:xfrm rot="5400000" flipH="1">
            <a:off x="1876743" y="2441937"/>
            <a:ext cx="31304" cy="822960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sz="900"/>
          </a:p>
        </p:txBody>
      </p:sp>
      <p:sp>
        <p:nvSpPr>
          <p:cNvPr id="65" name="Text Box 49"/>
          <p:cNvSpPr txBox="1">
            <a:spLocks noChangeArrowheads="1"/>
          </p:cNvSpPr>
          <p:nvPr/>
        </p:nvSpPr>
        <p:spPr bwMode="auto">
          <a:xfrm>
            <a:off x="1733798" y="2621112"/>
            <a:ext cx="291179" cy="158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4 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 Box 49"/>
          <p:cNvSpPr txBox="1">
            <a:spLocks noChangeArrowheads="1"/>
          </p:cNvSpPr>
          <p:nvPr/>
        </p:nvSpPr>
        <p:spPr bwMode="auto">
          <a:xfrm>
            <a:off x="719832" y="4655115"/>
            <a:ext cx="464608" cy="2528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1/2</a:t>
            </a:r>
          </a:p>
          <a:p>
            <a:pPr algn="r">
              <a:defRPr/>
            </a:pP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endParaRPr lang="en-US" sz="9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ight Bracket 66"/>
          <p:cNvSpPr/>
          <p:nvPr/>
        </p:nvSpPr>
        <p:spPr>
          <a:xfrm rot="5400000" flipH="1">
            <a:off x="1191482" y="2658163"/>
            <a:ext cx="31304" cy="390510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sz="900"/>
          </a:p>
        </p:txBody>
      </p:sp>
      <p:sp>
        <p:nvSpPr>
          <p:cNvPr id="68" name="Text Box 49"/>
          <p:cNvSpPr txBox="1">
            <a:spLocks noChangeArrowheads="1"/>
          </p:cNvSpPr>
          <p:nvPr/>
        </p:nvSpPr>
        <p:spPr bwMode="auto">
          <a:xfrm>
            <a:off x="1046610" y="2621112"/>
            <a:ext cx="345946" cy="158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 Box 49"/>
          <p:cNvSpPr txBox="1">
            <a:spLocks noChangeArrowheads="1"/>
          </p:cNvSpPr>
          <p:nvPr/>
        </p:nvSpPr>
        <p:spPr bwMode="auto">
          <a:xfrm>
            <a:off x="118391" y="2567735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 Box 50"/>
          <p:cNvSpPr txBox="1">
            <a:spLocks noChangeArrowheads="1"/>
          </p:cNvSpPr>
          <p:nvPr/>
        </p:nvSpPr>
        <p:spPr bwMode="auto">
          <a:xfrm rot="16200000">
            <a:off x="2363571" y="3469438"/>
            <a:ext cx="171072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ell free area</a:t>
            </a:r>
          </a:p>
          <a:p>
            <a:pPr algn="ctr">
              <a:defRPr/>
            </a:pP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fold change against average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 Box 26"/>
          <p:cNvSpPr txBox="1">
            <a:spLocks noChangeArrowheads="1"/>
          </p:cNvSpPr>
          <p:nvPr/>
        </p:nvSpPr>
        <p:spPr bwMode="auto">
          <a:xfrm rot="8075714" flipV="1">
            <a:off x="3453425" y="2234715"/>
            <a:ext cx="71883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XAV939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6" name="Chart 8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4730310"/>
              </p:ext>
            </p:extLst>
          </p:nvPr>
        </p:nvGraphicFramePr>
        <p:xfrm>
          <a:off x="546007" y="601576"/>
          <a:ext cx="2116771" cy="16818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87" name="Chart 8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3894494"/>
              </p:ext>
            </p:extLst>
          </p:nvPr>
        </p:nvGraphicFramePr>
        <p:xfrm>
          <a:off x="4590789" y="497505"/>
          <a:ext cx="2128212" cy="17447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88" name="Chart 8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8189483"/>
              </p:ext>
            </p:extLst>
          </p:nvPr>
        </p:nvGraphicFramePr>
        <p:xfrm>
          <a:off x="3370395" y="2840613"/>
          <a:ext cx="2038825" cy="17523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89" name="Text Box 26"/>
          <p:cNvSpPr txBox="1">
            <a:spLocks noChangeArrowheads="1"/>
          </p:cNvSpPr>
          <p:nvPr/>
        </p:nvSpPr>
        <p:spPr bwMode="auto">
          <a:xfrm>
            <a:off x="3879050" y="4494269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 Box 26"/>
          <p:cNvSpPr txBox="1">
            <a:spLocks noChangeArrowheads="1"/>
          </p:cNvSpPr>
          <p:nvPr/>
        </p:nvSpPr>
        <p:spPr bwMode="auto">
          <a:xfrm>
            <a:off x="4302590" y="4493658"/>
            <a:ext cx="97788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1/2</a:t>
            </a:r>
          </a:p>
          <a:p>
            <a:pPr algn="ctr" eaLnBrk="1" hangingPunct="1"/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 Box 51"/>
          <p:cNvSpPr txBox="1">
            <a:spLocks noChangeArrowheads="1"/>
          </p:cNvSpPr>
          <p:nvPr/>
        </p:nvSpPr>
        <p:spPr bwMode="auto">
          <a:xfrm>
            <a:off x="3965019" y="317485"/>
            <a:ext cx="409086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7397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197</TotalTime>
  <Words>356</Words>
  <Application>Microsoft Office PowerPoint</Application>
  <PresentationFormat>A4 Paper (210x297 mm)</PresentationFormat>
  <Paragraphs>4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Lupo</dc:creator>
  <cp:lastModifiedBy>ltrusolino</cp:lastModifiedBy>
  <cp:revision>564</cp:revision>
  <cp:lastPrinted>2014-11-21T15:42:42Z</cp:lastPrinted>
  <dcterms:created xsi:type="dcterms:W3CDTF">2006-08-16T00:00:00Z</dcterms:created>
  <dcterms:modified xsi:type="dcterms:W3CDTF">2015-12-14T09:17:22Z</dcterms:modified>
</cp:coreProperties>
</file>